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0D09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732" y="51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481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157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4554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1220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0991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869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6061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0394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6796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1627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9999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2F9D0-F1CD-416D-98C1-B7AE37D317B5}" type="datetimeFigureOut">
              <a:rPr lang="it-IT" smtClean="0"/>
              <a:t>28/05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EE644-4B3E-4E90-9A0E-767CD6806B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0097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96" name="Gruppo 7595"/>
          <p:cNvGrpSpPr/>
          <p:nvPr/>
        </p:nvGrpSpPr>
        <p:grpSpPr>
          <a:xfrm>
            <a:off x="563245" y="751785"/>
            <a:ext cx="5731510" cy="7780655"/>
            <a:chOff x="563245" y="751785"/>
            <a:chExt cx="5731510" cy="7780655"/>
          </a:xfrm>
        </p:grpSpPr>
        <p:pic>
          <p:nvPicPr>
            <p:cNvPr id="4" name="Immagine 3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245" y="751785"/>
              <a:ext cx="5731510" cy="778065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585" name="CasellaDiTesto 7584"/>
            <p:cNvSpPr txBox="1"/>
            <p:nvPr/>
          </p:nvSpPr>
          <p:spPr>
            <a:xfrm>
              <a:off x="4807992" y="863688"/>
              <a:ext cx="374400" cy="900000"/>
            </a:xfrm>
            <a:prstGeom prst="rect">
              <a:avLst/>
            </a:prstGeom>
            <a:noFill/>
            <a:ln w="1143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  <p:sp>
          <p:nvSpPr>
            <p:cNvPr id="7586" name="CasellaDiTesto 7585"/>
            <p:cNvSpPr txBox="1"/>
            <p:nvPr/>
          </p:nvSpPr>
          <p:spPr>
            <a:xfrm>
              <a:off x="3843080" y="1979712"/>
              <a:ext cx="306000" cy="900000"/>
            </a:xfrm>
            <a:prstGeom prst="rect">
              <a:avLst/>
            </a:prstGeom>
            <a:noFill/>
            <a:ln w="1143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it-IT" sz="500" dirty="0"/>
            </a:p>
          </p:txBody>
        </p:sp>
        <p:sp>
          <p:nvSpPr>
            <p:cNvPr id="7588" name="CasellaDiTesto 7587"/>
            <p:cNvSpPr txBox="1"/>
            <p:nvPr/>
          </p:nvSpPr>
          <p:spPr>
            <a:xfrm>
              <a:off x="2204864" y="4211960"/>
              <a:ext cx="374400" cy="900000"/>
            </a:xfrm>
            <a:prstGeom prst="rect">
              <a:avLst/>
            </a:prstGeom>
            <a:noFill/>
            <a:ln w="11430">
              <a:solidFill>
                <a:srgbClr val="50D09F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  <p:sp>
          <p:nvSpPr>
            <p:cNvPr id="7589" name="CasellaDiTesto 7588"/>
            <p:cNvSpPr txBox="1"/>
            <p:nvPr/>
          </p:nvSpPr>
          <p:spPr>
            <a:xfrm>
              <a:off x="4134720" y="4211960"/>
              <a:ext cx="288000" cy="900000"/>
            </a:xfrm>
            <a:prstGeom prst="rect">
              <a:avLst/>
            </a:prstGeom>
            <a:noFill/>
            <a:ln w="11430">
              <a:solidFill>
                <a:srgbClr val="50D09F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  <p:sp>
          <p:nvSpPr>
            <p:cNvPr id="7590" name="CasellaDiTesto 7589"/>
            <p:cNvSpPr txBox="1"/>
            <p:nvPr/>
          </p:nvSpPr>
          <p:spPr>
            <a:xfrm>
              <a:off x="5769280" y="4211960"/>
              <a:ext cx="180000" cy="900000"/>
            </a:xfrm>
            <a:prstGeom prst="rect">
              <a:avLst/>
            </a:prstGeom>
            <a:noFill/>
            <a:ln w="11430"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  <p:sp>
          <p:nvSpPr>
            <p:cNvPr id="7592" name="CasellaDiTesto 7591"/>
            <p:cNvSpPr txBox="1"/>
            <p:nvPr/>
          </p:nvSpPr>
          <p:spPr>
            <a:xfrm>
              <a:off x="1412776" y="5328184"/>
              <a:ext cx="288000" cy="900000"/>
            </a:xfrm>
            <a:prstGeom prst="rect">
              <a:avLst/>
            </a:prstGeom>
            <a:noFill/>
            <a:ln w="11430"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  <p:sp>
          <p:nvSpPr>
            <p:cNvPr id="7593" name="CasellaDiTesto 7592"/>
            <p:cNvSpPr txBox="1"/>
            <p:nvPr/>
          </p:nvSpPr>
          <p:spPr>
            <a:xfrm>
              <a:off x="5877272" y="863688"/>
              <a:ext cx="108000" cy="900000"/>
            </a:xfrm>
            <a:prstGeom prst="rect">
              <a:avLst/>
            </a:prstGeom>
            <a:noFill/>
            <a:ln w="1143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  <p:sp>
          <p:nvSpPr>
            <p:cNvPr id="7594" name="CasellaDiTesto 7593"/>
            <p:cNvSpPr txBox="1"/>
            <p:nvPr/>
          </p:nvSpPr>
          <p:spPr>
            <a:xfrm>
              <a:off x="1412776" y="1979712"/>
              <a:ext cx="324000" cy="900000"/>
            </a:xfrm>
            <a:prstGeom prst="rect">
              <a:avLst/>
            </a:prstGeom>
            <a:noFill/>
            <a:ln w="1143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it-IT" sz="500" dirty="0" smtClean="0"/>
                <a:t>                      </a:t>
              </a:r>
              <a:endParaRPr lang="it-IT" sz="500" dirty="0"/>
            </a:p>
          </p:txBody>
        </p:sp>
      </p:grpSp>
      <p:sp>
        <p:nvSpPr>
          <p:cNvPr id="7595" name="Rettangolo 7594"/>
          <p:cNvSpPr/>
          <p:nvPr/>
        </p:nvSpPr>
        <p:spPr>
          <a:xfrm>
            <a:off x="404664" y="8547843"/>
            <a:ext cx="619268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800" dirty="0"/>
              <a:t>Figure S1: </a:t>
            </a:r>
            <a:r>
              <a:rPr lang="en-US" sz="800" dirty="0"/>
              <a:t>Amino acid alignment of the Italian PPV7 NS1 sequences with NC040562 reference </a:t>
            </a:r>
            <a:r>
              <a:rPr lang="en-US" sz="800" dirty="0" smtClean="0"/>
              <a:t>strain. The three replication initiation motifs (aa 76-83; 100-106; 154-163), </a:t>
            </a:r>
            <a:r>
              <a:rPr lang="en-US" sz="800" dirty="0"/>
              <a:t>t</a:t>
            </a:r>
            <a:r>
              <a:rPr lang="en-US" sz="800" dirty="0" smtClean="0"/>
              <a:t>he two NTP-binding motifs (aa 319-326; 361-366) and the helicase domain (aa 397-405), necessary for parvovirus replication, are evidenced in red, green and blue squares, respectively.</a:t>
            </a:r>
            <a:endParaRPr lang="it-IT" sz="800" dirty="0"/>
          </a:p>
        </p:txBody>
      </p:sp>
    </p:spTree>
    <p:extLst>
      <p:ext uri="{BB962C8B-B14F-4D97-AF65-F5344CB8AC3E}">
        <p14:creationId xmlns:p14="http://schemas.microsoft.com/office/powerpoint/2010/main" val="2463260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72</Words>
  <Application>Microsoft Office PowerPoint</Application>
  <PresentationFormat>Presentazione su schermo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ei Giudici Silvia</dc:creator>
  <cp:lastModifiedBy>Dei Giudici Silvia</cp:lastModifiedBy>
  <cp:revision>16</cp:revision>
  <dcterms:created xsi:type="dcterms:W3CDTF">2024-05-10T08:39:05Z</dcterms:created>
  <dcterms:modified xsi:type="dcterms:W3CDTF">2024-05-28T16:14:37Z</dcterms:modified>
</cp:coreProperties>
</file>